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504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044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220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617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341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037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555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62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848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102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418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60F510-B979-458B-BE3E-5A489F1E6C69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02474-2821-4F09-B11F-06EE99692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177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2303"/>
            <a:ext cx="4191000" cy="36264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9127" y="3125554"/>
            <a:ext cx="3810000" cy="33730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114301" y="4191000"/>
            <a:ext cx="39624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ught (a) and salinity (2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) stress response of grape varieties. Q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alat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A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bz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oo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Z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bz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oo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j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oo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 =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dane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fi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1 = control, 2 = - 1.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p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rought stress. Picture was taken three weeks and two weeks after drought (a) and salinity (b) stress treatment, respectively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91001" y="1752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265797" y="5334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564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sakh, Niranjan</dc:creator>
  <cp:lastModifiedBy>Baisakh, Niranjan</cp:lastModifiedBy>
  <cp:revision>1</cp:revision>
  <dcterms:created xsi:type="dcterms:W3CDTF">2015-07-17T02:47:00Z</dcterms:created>
  <dcterms:modified xsi:type="dcterms:W3CDTF">2015-07-17T02:49:47Z</dcterms:modified>
</cp:coreProperties>
</file>